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3969" autoAdjust="0"/>
  </p:normalViewPr>
  <p:slideViewPr>
    <p:cSldViewPr snapToGrid="0">
      <p:cViewPr varScale="1">
        <p:scale>
          <a:sx n="104" d="100"/>
          <a:sy n="104" d="100"/>
        </p:scale>
        <p:origin x="7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894C21E-C7E3-48CD-A6C8-17A1DAD339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3BF3D749-73CA-4FC2-A743-E4A9BBBCEF5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0D646DE-C80D-45E8-A79A-C723893B72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3DA8EF-18E1-4824-B06D-68D219E800C3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29FC446-C0AB-4ADD-AFEA-F120595A71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82E7389-CA9E-4032-8D2A-CB131D74AE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5E76F-9C02-49B9-A7F5-3B34DC38FC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551597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2FD3663-D8D5-4443-92A0-984B118A49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38043A9-09A9-451D-9651-FE2BCB6394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697563E-0174-4584-B333-AE737F585F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3DA8EF-18E1-4824-B06D-68D219E800C3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CB5BC89-2598-46E9-AB02-4A1D89D16F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A820F8D-14C5-4B4D-A576-CD565DC199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5E76F-9C02-49B9-A7F5-3B34DC38FC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13999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F6D676AC-44E2-48C1-A61F-303D2FE71CF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2E1AC040-2494-4A07-AD12-EDB9EDE8C3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9B40E19-79C2-4265-83DD-9B3888AFF0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3DA8EF-18E1-4824-B06D-68D219E800C3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61AC8CA-CE44-41E1-AB69-35D82C1F23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B4F22B7-1958-4C6A-92DD-21D6E7D8BB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5E76F-9C02-49B9-A7F5-3B34DC38FC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6490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C100E2F-7792-4B26-906C-91D73C2B3B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E94114A-E662-44AA-8277-764692E679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C821386-7C4A-4F76-95BA-8F229C1C24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3DA8EF-18E1-4824-B06D-68D219E800C3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448B4C4-2772-4CDC-897C-C47C7DD8D1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7F9533E-B58B-4593-8314-5C1E5A3C56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5E76F-9C02-49B9-A7F5-3B34DC38FC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1792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C0BA381-8170-465B-BDB0-7FD6451259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54B52B1-8BDC-4CC7-9E57-50F5AEBF70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EE1ADF4-349B-4F22-84D1-673170CE41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3DA8EF-18E1-4824-B06D-68D219E800C3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EA326D2-5284-4BFE-85C2-9BD17B68D6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A357CDE-B6CC-4DC6-B82D-80EF19AA1C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5E76F-9C02-49B9-A7F5-3B34DC38FC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818717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F733204-C60E-4B4E-BC40-7F1A640A19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751B38A-EC24-4C58-AF8C-35B0516D63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F166255-0C58-4462-B28D-F1CDAD10D9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F6FA5EC-1AC2-43DF-BBC1-45C6EB1E00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3DA8EF-18E1-4824-B06D-68D219E800C3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1E40A4F-436D-470B-8D75-4FC10A3DC3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94D0CBC-7FDD-46AC-8C2E-355EF142A8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5E76F-9C02-49B9-A7F5-3B34DC38FC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5182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988F8EE-C940-4262-9391-B530B0FC60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D3A1946-E581-46BD-AC4D-204533E64C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9BF60EC-FE91-4F4A-BD00-417C1649B1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FBFE7795-2362-45D1-BBD9-CD1F75C128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6518D7DD-9120-4CC9-B6DD-402C05A567A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82B95A61-D44A-4634-B437-02E906713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3DA8EF-18E1-4824-B06D-68D219E800C3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B1A62BC4-5EDA-4B9F-846F-3C3056182E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04214569-987E-4A20-A9D3-7D33410946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5E76F-9C02-49B9-A7F5-3B34DC38FC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174225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4C2CCF8-E781-4397-BB6B-3D56929EA6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A45F63D8-518A-42D1-993D-713615075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3DA8EF-18E1-4824-B06D-68D219E800C3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6498D261-632D-4BEE-A6C9-B26C391469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D4D2DBAE-773A-4306-832B-2B88B6CDB0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5E76F-9C02-49B9-A7F5-3B34DC38FC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221827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4F9D63C5-446F-4F35-B3D1-CE0C865508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3DA8EF-18E1-4824-B06D-68D219E800C3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1FD4B067-D785-4B16-8A34-5CF11B6B1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F086F239-6165-45A0-810B-4B593F1ADA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5E76F-9C02-49B9-A7F5-3B34DC38FC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8131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C6B71BC-A149-4606-822D-33F3BBDC71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A62A625-EFDD-4D98-B79F-C99A037098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7AD33090-FD7C-432B-95A1-47A5536AB2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CA4A604-0C13-4D67-979D-09B692C5B6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3DA8EF-18E1-4824-B06D-68D219E800C3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E8D0FA1-A6F6-4A1C-B1F8-5442B4952D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032C1A5-5B18-4107-8606-522FB9CBB9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5E76F-9C02-49B9-A7F5-3B34DC38FC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9681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5EF6CF4-45E9-450D-869D-5BB9624692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21FED88B-4EF2-4532-BED9-8CCE65B97F0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079094A7-04CF-4496-A591-27C83E27E5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E01A648-8211-4AA3-8484-D76C604857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3DA8EF-18E1-4824-B06D-68D219E800C3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532C08B-19AB-4757-A943-E76651FFC0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7AC5484-449E-4BE4-9BCC-611910D198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5E76F-9C02-49B9-A7F5-3B34DC38FC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27295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06AD8F06-6667-4B23-9F35-4A9AC51F51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70763F1-172D-494E-80DB-5A27FE3EBE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51D5E15-A4C3-4537-B414-FAC0901B5D7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3DA8EF-18E1-4824-B06D-68D219E800C3}" type="datetimeFigureOut">
              <a:rPr lang="it-IT" smtClean="0"/>
              <a:t>31/07/2019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C9805EB-14BF-48C6-9F18-B95D607D34E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19A1DF4-19AB-4D9B-96AB-D1FDADB15E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55E76F-9C02-49B9-A7F5-3B34DC38FC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61210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899B331B-891B-45F8-A1A5-1CB073C2227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40" b="18427"/>
          <a:stretch/>
        </p:blipFill>
        <p:spPr>
          <a:xfrm>
            <a:off x="3498491" y="283253"/>
            <a:ext cx="5156560" cy="4544484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0BA16698-E47C-486F-8C33-D4476FFD8CC2}"/>
              </a:ext>
            </a:extLst>
          </p:cNvPr>
          <p:cNvSpPr txBox="1"/>
          <p:nvPr/>
        </p:nvSpPr>
        <p:spPr>
          <a:xfrm>
            <a:off x="4282440" y="4960160"/>
            <a:ext cx="845820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WM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04D2629A-A123-41FE-8AC9-F9275A24C320}"/>
              </a:ext>
            </a:extLst>
          </p:cNvPr>
          <p:cNvSpPr txBox="1"/>
          <p:nvPr/>
        </p:nvSpPr>
        <p:spPr>
          <a:xfrm>
            <a:off x="5231130" y="4975400"/>
            <a:ext cx="76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M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F7291426-E060-4B91-9849-FC54C5ABFA47}"/>
              </a:ext>
            </a:extLst>
          </p:cNvPr>
          <p:cNvSpPr txBox="1"/>
          <p:nvPr/>
        </p:nvSpPr>
        <p:spPr>
          <a:xfrm>
            <a:off x="6096000" y="4975400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7782156D-F354-4EEC-803B-A07C4DFB34AD}"/>
              </a:ext>
            </a:extLst>
          </p:cNvPr>
          <p:cNvSpPr txBox="1"/>
          <p:nvPr/>
        </p:nvSpPr>
        <p:spPr>
          <a:xfrm>
            <a:off x="6869430" y="4975400"/>
            <a:ext cx="76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317E0D2C-3680-4E98-BEC5-3C26598F27E4}"/>
              </a:ext>
            </a:extLst>
          </p:cNvPr>
          <p:cNvSpPr txBox="1"/>
          <p:nvPr/>
        </p:nvSpPr>
        <p:spPr>
          <a:xfrm>
            <a:off x="7802880" y="4975400"/>
            <a:ext cx="594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1" name="Rettangolo 10"/>
          <p:cNvSpPr/>
          <p:nvPr/>
        </p:nvSpPr>
        <p:spPr>
          <a:xfrm>
            <a:off x="344557" y="5591940"/>
            <a:ext cx="11529390" cy="12777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GB" b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b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9.</a:t>
            </a:r>
            <a:r>
              <a:rPr lang="en-GB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stribution of F</a:t>
            </a:r>
            <a:r>
              <a:rPr lang="en-GB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values at the 6,693 SNP loci identified in this study. Each boxplot refers to the pairwise comparison between one of the five k-means clusters and the remaining non-redundant accessions in the collection. Dots indicate outliers with high F</a:t>
            </a:r>
            <a:r>
              <a:rPr lang="en-GB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values, indicating highly divergent alleles which might be used to set-up cluster identification keys. 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065683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68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hiara Delvento</dc:creator>
  <cp:lastModifiedBy>Utente</cp:lastModifiedBy>
  <cp:revision>4</cp:revision>
  <dcterms:created xsi:type="dcterms:W3CDTF">2019-07-10T16:35:13Z</dcterms:created>
  <dcterms:modified xsi:type="dcterms:W3CDTF">2019-07-31T07:43:06Z</dcterms:modified>
</cp:coreProperties>
</file>